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>
        <p:scale>
          <a:sx n="75" d="100"/>
          <a:sy n="75" d="100"/>
        </p:scale>
        <p:origin x="366" y="-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D26D1D-2C0F-433A-B64B-56221B38FA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10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7389777"/>
              </p:ext>
            </p:extLst>
          </p:nvPr>
        </p:nvGraphicFramePr>
        <p:xfrm>
          <a:off x="336550" y="1066800"/>
          <a:ext cx="3765550" cy="328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3636000" imgH="3384000" progId="Prism5.Document">
                  <p:embed/>
                </p:oleObj>
              </mc:Choice>
              <mc:Fallback>
                <p:oleObj name="Prism Project" r:id="rId3" imgW="3636000" imgH="3384000" progId="Prism5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6550" y="1066800"/>
                        <a:ext cx="3765550" cy="328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337569" y="475580"/>
            <a:ext cx="17620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V-specific IgG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titers in serum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02164" y="4066500"/>
            <a:ext cx="324994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 Fig.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N biofilm increased geometric mean titer HRV specific IgG in serum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represented means ± SEM. Gnotobiotic pigs were transplanted with human infant fecal microbiota (HIFM) at 4 days of age, post-HIFM transplantation day (PTD) 0. Pigs were fed protein deficient diet. Probiotic was given to respective groups at PTD 11, challenged with virulent human rotavirus (VirHRV) on PTD13/post-challenge day (PCD) 0 and euthanized on PTD 27/PCD 14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33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97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21Z</dcterms:modified>
</cp:coreProperties>
</file>